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97866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15691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52316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34162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24509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20957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66889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77259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8701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0433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2801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4DEAA-7316-48A1-9AD7-BB61B2BC0FD5}" type="datetimeFigureOut">
              <a:rPr lang="es-MX" smtClean="0"/>
              <a:t>02/06/2026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81953-EFC3-47D8-B69F-C3F595DB3CA8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96678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6938" y="1099930"/>
            <a:ext cx="4249530" cy="3187148"/>
          </a:xfrm>
          <a:prstGeom prst="rect">
            <a:avLst/>
          </a:prstGeom>
        </p:spPr>
      </p:pic>
      <p:pic>
        <p:nvPicPr>
          <p:cNvPr id="3" name="Imagen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304" y="1315277"/>
            <a:ext cx="3962401" cy="2971801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1686" y="1505778"/>
            <a:ext cx="3167270" cy="2375452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331306" y="1306998"/>
            <a:ext cx="3975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MX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4472614" y="1446146"/>
            <a:ext cx="3975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MX" sz="2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7745910" y="1128094"/>
            <a:ext cx="3975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22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s-MX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ángulo 7"/>
          <p:cNvSpPr/>
          <p:nvPr/>
        </p:nvSpPr>
        <p:spPr>
          <a:xfrm>
            <a:off x="742121" y="4826085"/>
            <a:ext cx="9130750" cy="7092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5.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emale of </a:t>
            </a:r>
            <a:r>
              <a:rPr lang="en-US" b="1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chromomyia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meca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b="1" i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meca</a:t>
            </a:r>
            <a:r>
              <a:rPr lang="en-US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: Front view of the head, B: Red arrow points to th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ibarium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osterior teeth; C: Lateral view of the genital apparatus.</a:t>
            </a:r>
            <a:endParaRPr lang="es-MX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0" name="Conector recto de flecha 9"/>
          <p:cNvCxnSpPr/>
          <p:nvPr/>
        </p:nvCxnSpPr>
        <p:spPr>
          <a:xfrm flipH="1">
            <a:off x="6016487" y="1974574"/>
            <a:ext cx="212035" cy="238539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13880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Panorámica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José Ríos Tostado</dc:creator>
  <cp:lastModifiedBy>Juan José Ríos Tostado</cp:lastModifiedBy>
  <cp:revision>1</cp:revision>
  <dcterms:created xsi:type="dcterms:W3CDTF">2026-06-03T04:12:21Z</dcterms:created>
  <dcterms:modified xsi:type="dcterms:W3CDTF">2026-06-03T04:13:07Z</dcterms:modified>
</cp:coreProperties>
</file>